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68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2C58D2-F5E5-4239-8EDC-7EC7E93E73E7}" type="datetimeFigureOut">
              <a:rPr lang="en-GB" smtClean="0"/>
              <a:t>05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EFD6E-F9EE-4533-8FD5-76BC4A36738D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t="55774" r="75102"/>
          <a:stretch/>
        </p:blipFill>
        <p:spPr bwMode="auto">
          <a:xfrm>
            <a:off x="1475657" y="1556792"/>
            <a:ext cx="2736304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TextBox 8"/>
          <p:cNvSpPr txBox="1"/>
          <p:nvPr/>
        </p:nvSpPr>
        <p:spPr>
          <a:xfrm>
            <a:off x="5148065" y="1196752"/>
            <a:ext cx="17497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i="1" dirty="0" smtClean="0"/>
              <a:t>ER-negative</a:t>
            </a:r>
            <a:endParaRPr lang="en-GB" sz="1400" b="1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2228511" y="1196752"/>
            <a:ext cx="1446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i="1" dirty="0" smtClean="0"/>
              <a:t>TNBC</a:t>
            </a:r>
            <a:endParaRPr lang="en-GB" sz="1400" b="1" i="1" dirty="0"/>
          </a:p>
        </p:txBody>
      </p:sp>
      <p:sp>
        <p:nvSpPr>
          <p:cNvPr id="13" name="TextBox 12"/>
          <p:cNvSpPr txBox="1"/>
          <p:nvPr/>
        </p:nvSpPr>
        <p:spPr>
          <a:xfrm>
            <a:off x="1331640" y="188640"/>
            <a:ext cx="6500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err="1" smtClean="0"/>
              <a:t>qqplots</a:t>
            </a:r>
            <a:r>
              <a:rPr lang="en-GB" b="1" dirty="0" smtClean="0"/>
              <a:t>: DMFS </a:t>
            </a:r>
            <a:r>
              <a:rPr lang="en-GB" b="1" dirty="0" err="1" smtClean="0"/>
              <a:t>cox</a:t>
            </a:r>
            <a:r>
              <a:rPr lang="en-GB" b="1" dirty="0" smtClean="0"/>
              <a:t>-regression p-values </a:t>
            </a:r>
            <a:r>
              <a:rPr lang="en-GB" b="1" dirty="0" err="1" smtClean="0"/>
              <a:t>vs</a:t>
            </a:r>
            <a:r>
              <a:rPr lang="en-GB" b="1" dirty="0" smtClean="0"/>
              <a:t> uniform distribution</a:t>
            </a:r>
            <a:endParaRPr lang="en-GB" b="1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49458" t="56108" r="26210"/>
          <a:stretch/>
        </p:blipFill>
        <p:spPr bwMode="auto">
          <a:xfrm>
            <a:off x="4427985" y="1556792"/>
            <a:ext cx="2694494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0"/>
          <p:cNvSpPr txBox="1"/>
          <p:nvPr/>
        </p:nvSpPr>
        <p:spPr>
          <a:xfrm>
            <a:off x="539552" y="1988840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914691" y="2333783"/>
            <a:ext cx="136815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uniform distribution</a:t>
            </a:r>
            <a:endParaRPr lang="en-GB" sz="10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267745" y="3501008"/>
            <a:ext cx="136815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log-rank p-values</a:t>
            </a:r>
            <a:endParaRPr lang="en-GB" sz="1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5364089" y="3501008"/>
            <a:ext cx="136815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log-rank p-values</a:t>
            </a:r>
            <a:endParaRPr lang="en-GB" sz="100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3939027" y="2261774"/>
            <a:ext cx="136815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uniform distribution</a:t>
            </a:r>
            <a:endParaRPr lang="en-GB" sz="10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</TotalTime>
  <Words>18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CR-K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CR</dc:creator>
  <cp:lastModifiedBy>Emanuele de Rinaldis</cp:lastModifiedBy>
  <cp:revision>5</cp:revision>
  <dcterms:created xsi:type="dcterms:W3CDTF">2012-04-27T14:10:52Z</dcterms:created>
  <dcterms:modified xsi:type="dcterms:W3CDTF">2013-06-05T17:40:37Z</dcterms:modified>
</cp:coreProperties>
</file>